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9" r:id="rId4"/>
    <p:sldId id="258" r:id="rId5"/>
    <p:sldId id="264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4" autoAdjust="0"/>
    <p:restoredTop sz="94694"/>
  </p:normalViewPr>
  <p:slideViewPr>
    <p:cSldViewPr snapToGrid="0">
      <p:cViewPr varScale="1">
        <p:scale>
          <a:sx n="117" d="100"/>
          <a:sy n="117" d="100"/>
        </p:scale>
        <p:origin x="84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A95EE2-7128-4233-ACC6-D9507EF89ED6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183E4D-EF3D-44BB-93A3-088F161AC2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1695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.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183E4D-EF3D-44BB-93A3-088F161AC2F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60707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. 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183E4D-EF3D-44BB-93A3-088F161AC2F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35377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. 4c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183E4D-EF3D-44BB-93A3-088F161AC2F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07100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. </a:t>
            </a:r>
            <a:r>
              <a:rPr lang="en-US"/>
              <a:t>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3183E4D-EF3D-44BB-93A3-088F161AC2F0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8336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4C1C70-83C0-62DF-82CA-54F3B324B0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E15E47F-740A-B2B4-80D2-23DD34C824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46AFB5-43AD-CE5B-982A-A0BED4ED6D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B76F30-7E19-C116-2C34-8339F8937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B86167-4218-C2BF-2F20-0A247810AC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940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10F6C1-9010-BD91-275C-98450A36B5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5400220-DFE7-00E6-B075-82C98489E5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653AA9-4143-2C9D-BD57-01742BFF0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6BD3FD-6146-FA8A-0324-790E64BF7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8415B1-3CBF-F079-4EA0-FC97640404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629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DAD9C4-2907-3B4D-F061-43D4B1AFDAE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EDAED15-3447-5F87-11A0-3F92630729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D1810B-0042-F6A5-366E-A92F27444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18A194-6DBB-18A3-D9F7-A7990228F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0B422F-7DD3-CC48-EC2E-60E1EE40C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931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01732A-FEF0-A0FD-3392-EB632E8F60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F0EDAB-1578-2F3F-D822-77F7ECD8B8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3FDE21-A76E-A59C-1A1E-C0ABC200D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3E6455-9F08-069B-EE6C-9B5176AED6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691DCF-00D7-3F7D-50D0-D43E1D435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937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8C07CC-EBF4-C140-9876-97EE8307C4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48AC93-407E-DF19-4503-28D0E163FA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71492B-15F5-9F3F-D80B-65CC671C85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980306-D1D1-4C8A-C4CA-DAFB277E03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CFA5D3-8E18-20C1-926B-70678022E3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6183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8BC40D-8AF4-C76A-2D9D-EFF71661DA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14BBCEC-AF25-6D52-59C0-C9C0687B3C8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12B880-D052-D7DD-FF4C-6F4DC98E70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464C155-2740-62FC-0058-E298CE78E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99E4E4-094D-98E8-C547-1C0F264229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2ECBA7B-54A3-0107-F9E3-D32593C104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6867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718D1B-BA79-8D0C-3E69-0A45D8C429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51CAC2F-200B-1AC7-A4B8-36C4732876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B4D1EE7-C0F3-2618-7A32-440E873B69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D3D5FAA-8202-B2A1-CDD5-734BE8E1DC0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8946C4D-8617-0AC7-6127-97716EB5D7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761DF88-1953-2B89-81DE-A574F67B9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92EBC1E-1F57-DF90-7B1D-71B44AD473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1DC9D6-CD29-6170-0780-3A295F3E9E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5460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F30E3A-F7B4-37D1-2467-D34758C748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3A85660-4173-8B0E-3EF2-0D8BBCFA9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4E01AF-E974-E19A-B604-3EB31F3AEE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3BEF4D2-D6AB-91E7-CD1F-667FB1633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9834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623220-9CCF-92C1-5332-832481B98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BC45E9-0555-6082-A76B-3BEC9104A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0B7673E-133D-908D-FF82-13FBE86C7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1509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7E2D48-E48A-6A18-E74E-C182A56C0F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275734-0927-4801-EFC3-98730ECB77D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BC9DCE-5222-6F13-041E-E16A326FF3A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F0EFBA-EDF7-7A65-A888-E935916B5A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432317-E223-88FF-41C6-7C07B7462A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6D361A-BD03-395E-FC79-9212C2F4EA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8014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054662-7090-0328-4F56-CCC0A2A93F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D24969D-0042-E71E-B3D0-00AC4139DCA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32C169-C10C-BEAC-CE8F-6EF7CBB9C0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A376FB-2B23-2B75-8EB9-18D8C68ED8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043A908-6025-59B0-58A8-90B7A51F7E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E47A9-D872-089E-5B4B-8D8E68282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51927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04E94B-C6A5-577E-F2BF-5497BE4FF0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87B388-AA37-E6FA-D5C1-7C97BCF135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03695E-CF57-3905-391E-AC6B26BB249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F38156-8AAF-4B6F-BCC0-6D1430CC2851}" type="datetimeFigureOut">
              <a:rPr lang="en-US" smtClean="0"/>
              <a:t>10/27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D47FAD-D163-8586-876E-3B9B8665D3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9B5E8E-388D-9266-1DDB-1FB17025725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D1B4505-C9CB-4C48-BD73-8111010B3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03564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3" Type="http://schemas.openxmlformats.org/officeDocument/2006/relationships/image" Target="../media/image1.tif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g"/><Relationship Id="rId3" Type="http://schemas.openxmlformats.org/officeDocument/2006/relationships/image" Target="../media/image7.jpg"/><Relationship Id="rId7" Type="http://schemas.openxmlformats.org/officeDocument/2006/relationships/image" Target="../media/image4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g"/><Relationship Id="rId5" Type="http://schemas.openxmlformats.org/officeDocument/2006/relationships/image" Target="../media/image9.jp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g"/><Relationship Id="rId3" Type="http://schemas.openxmlformats.org/officeDocument/2006/relationships/image" Target="../media/image11.jpg"/><Relationship Id="rId7" Type="http://schemas.openxmlformats.org/officeDocument/2006/relationships/image" Target="../media/image14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jpg"/><Relationship Id="rId4" Type="http://schemas.openxmlformats.org/officeDocument/2006/relationships/image" Target="../media/image4.png"/><Relationship Id="rId9" Type="http://schemas.openxmlformats.org/officeDocument/2006/relationships/image" Target="../media/image16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g"/><Relationship Id="rId3" Type="http://schemas.openxmlformats.org/officeDocument/2006/relationships/image" Target="../media/image17.jpg"/><Relationship Id="rId7" Type="http://schemas.openxmlformats.org/officeDocument/2006/relationships/image" Target="../media/image20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g"/><Relationship Id="rId5" Type="http://schemas.openxmlformats.org/officeDocument/2006/relationships/image" Target="../media/image4.png"/><Relationship Id="rId4" Type="http://schemas.openxmlformats.org/officeDocument/2006/relationships/image" Target="../media/image18.jpg"/><Relationship Id="rId9" Type="http://schemas.openxmlformats.org/officeDocument/2006/relationships/image" Target="../media/image1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 descr="A close-up of a white background&#10;&#10;AI-generated content may be incorrect.">
            <a:extLst>
              <a:ext uri="{FF2B5EF4-FFF2-40B4-BE49-F238E27FC236}">
                <a16:creationId xmlns:a16="http://schemas.microsoft.com/office/drawing/2014/main" id="{3700A4A0-D5F1-E01A-F03A-1A491022B87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1777"/>
          <a:stretch>
            <a:fillRect/>
          </a:stretch>
        </p:blipFill>
        <p:spPr>
          <a:xfrm>
            <a:off x="5496563" y="3778863"/>
            <a:ext cx="1649165" cy="2734056"/>
          </a:xfrm>
          <a:prstGeom prst="rect">
            <a:avLst/>
          </a:prstGeom>
        </p:spPr>
      </p:pic>
      <p:pic>
        <p:nvPicPr>
          <p:cNvPr id="21" name="Picture 20" descr="A row of black dots&#10;&#10;AI-generated content may be incorrect.">
            <a:extLst>
              <a:ext uri="{FF2B5EF4-FFF2-40B4-BE49-F238E27FC236}">
                <a16:creationId xmlns:a16="http://schemas.microsoft.com/office/drawing/2014/main" id="{250761D0-9FCE-6F31-70DE-BA3E3CB7982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09611" y="4123944"/>
            <a:ext cx="3419856" cy="2734056"/>
          </a:xfrm>
          <a:prstGeom prst="rect">
            <a:avLst/>
          </a:prstGeom>
        </p:spPr>
      </p:pic>
      <p:pic>
        <p:nvPicPr>
          <p:cNvPr id="25" name="Picture 24" descr="A close-up of a test&#10;&#10;AI-generated content may be incorrect.">
            <a:extLst>
              <a:ext uri="{FF2B5EF4-FFF2-40B4-BE49-F238E27FC236}">
                <a16:creationId xmlns:a16="http://schemas.microsoft.com/office/drawing/2014/main" id="{B2808FFE-A296-9ADA-7483-E81F65EB89D4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0511" y="429304"/>
            <a:ext cx="3419856" cy="273405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571B101D-BBB5-BC8E-75FF-EA05D13D79A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835460" y="1138323"/>
            <a:ext cx="843026" cy="194230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9FF487C-BB44-F822-7497-C3B0C00372A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009253" y="4491124"/>
            <a:ext cx="812108" cy="1871070"/>
          </a:xfrm>
          <a:prstGeom prst="rect">
            <a:avLst/>
          </a:prstGeom>
        </p:spPr>
      </p:pic>
      <p:pic>
        <p:nvPicPr>
          <p:cNvPr id="2" name="Picture 1" descr="A close-up of a test results&#10;&#10;Description automatically generated">
            <a:extLst>
              <a:ext uri="{FF2B5EF4-FFF2-40B4-BE49-F238E27FC236}">
                <a16:creationId xmlns:a16="http://schemas.microsoft.com/office/drawing/2014/main" id="{7B11AE15-4C24-FB7A-0AD4-F7407FE43134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r="50620" b="76264"/>
          <a:stretch>
            <a:fillRect/>
          </a:stretch>
        </p:blipFill>
        <p:spPr>
          <a:xfrm>
            <a:off x="942010" y="2628909"/>
            <a:ext cx="2426208" cy="1634993"/>
          </a:xfrm>
          <a:prstGeom prst="rect">
            <a:avLst/>
          </a:prstGeom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A7EFA07D-E65A-91D5-38A0-232214409718}"/>
              </a:ext>
            </a:extLst>
          </p:cNvPr>
          <p:cNvGrpSpPr/>
          <p:nvPr/>
        </p:nvGrpSpPr>
        <p:grpSpPr>
          <a:xfrm>
            <a:off x="8350381" y="346570"/>
            <a:ext cx="3419856" cy="2734056"/>
            <a:chOff x="8772144" y="0"/>
            <a:chExt cx="3419856" cy="2734056"/>
          </a:xfrm>
        </p:grpSpPr>
        <p:pic>
          <p:nvPicPr>
            <p:cNvPr id="23" name="Picture 22" descr="A close-up of a test&#10;&#10;AI-generated content may be incorrect.">
              <a:extLst>
                <a:ext uri="{FF2B5EF4-FFF2-40B4-BE49-F238E27FC236}">
                  <a16:creationId xmlns:a16="http://schemas.microsoft.com/office/drawing/2014/main" id="{E52F737F-18F9-0E68-26B4-FB799235A21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312786">
              <a:off x="8772144" y="0"/>
              <a:ext cx="3419856" cy="2734056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58E7A4E8-3A02-16C3-C4DD-67975E73A1A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998026" y="167171"/>
              <a:ext cx="843026" cy="1942303"/>
            </a:xfrm>
            <a:prstGeom prst="rect">
              <a:avLst/>
            </a:prstGeom>
          </p:spPr>
        </p:pic>
      </p:grpSp>
      <p:pic>
        <p:nvPicPr>
          <p:cNvPr id="4" name="Picture 3">
            <a:extLst>
              <a:ext uri="{FF2B5EF4-FFF2-40B4-BE49-F238E27FC236}">
                <a16:creationId xmlns:a16="http://schemas.microsoft.com/office/drawing/2014/main" id="{46A8B142-A2A7-93FD-AD11-471824BB566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471255" y="4519820"/>
            <a:ext cx="843026" cy="194230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CF61392-81BD-ECBF-C105-C81E8C43B6B9}"/>
              </a:ext>
            </a:extLst>
          </p:cNvPr>
          <p:cNvSpPr txBox="1"/>
          <p:nvPr/>
        </p:nvSpPr>
        <p:spPr>
          <a:xfrm>
            <a:off x="5450618" y="153658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RAF3IP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43F90EA-2655-1C0B-5ADD-8D7E1CEA7154}"/>
              </a:ext>
            </a:extLst>
          </p:cNvPr>
          <p:cNvSpPr txBox="1"/>
          <p:nvPr/>
        </p:nvSpPr>
        <p:spPr>
          <a:xfrm>
            <a:off x="9755081" y="173540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AMP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DBE0926-8FB1-8414-4C53-B87DE0038715}"/>
              </a:ext>
            </a:extLst>
          </p:cNvPr>
          <p:cNvSpPr txBox="1"/>
          <p:nvPr/>
        </p:nvSpPr>
        <p:spPr>
          <a:xfrm>
            <a:off x="5512237" y="3307907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SIRT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73934E9-8F0E-0585-E55D-6D2B2A6E8B6D}"/>
              </a:ext>
            </a:extLst>
          </p:cNvPr>
          <p:cNvSpPr txBox="1"/>
          <p:nvPr/>
        </p:nvSpPr>
        <p:spPr>
          <a:xfrm>
            <a:off x="9603511" y="3842818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200" dirty="0"/>
              <a:t>β</a:t>
            </a:r>
            <a:r>
              <a:rPr lang="en-US" sz="1200" dirty="0"/>
              <a:t>-Actin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E3CE21B6-766C-96CD-096A-7DA321314A25}"/>
              </a:ext>
            </a:extLst>
          </p:cNvPr>
          <p:cNvSpPr/>
          <p:nvPr/>
        </p:nvSpPr>
        <p:spPr>
          <a:xfrm>
            <a:off x="5678486" y="1665514"/>
            <a:ext cx="1467242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F9BEB90F-FD6D-C2B9-C4B2-D502C543F8AF}"/>
              </a:ext>
            </a:extLst>
          </p:cNvPr>
          <p:cNvSpPr/>
          <p:nvPr/>
        </p:nvSpPr>
        <p:spPr>
          <a:xfrm>
            <a:off x="5786049" y="4786662"/>
            <a:ext cx="1467242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6B8B685-A682-B5C1-1EFD-3F8FE35110F8}"/>
              </a:ext>
            </a:extLst>
          </p:cNvPr>
          <p:cNvSpPr/>
          <p:nvPr/>
        </p:nvSpPr>
        <p:spPr>
          <a:xfrm>
            <a:off x="9311277" y="5426659"/>
            <a:ext cx="1467242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0A819683-82A1-8FFB-91EB-8892854AA92F}"/>
              </a:ext>
            </a:extLst>
          </p:cNvPr>
          <p:cNvSpPr/>
          <p:nvPr/>
        </p:nvSpPr>
        <p:spPr>
          <a:xfrm>
            <a:off x="10407021" y="1394025"/>
            <a:ext cx="1467242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Title 19">
            <a:extLst>
              <a:ext uri="{FF2B5EF4-FFF2-40B4-BE49-F238E27FC236}">
                <a16:creationId xmlns:a16="http://schemas.microsoft.com/office/drawing/2014/main" id="{131314B0-81D6-3827-D790-9CD8537E10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3202594" cy="1325563"/>
          </a:xfrm>
        </p:spPr>
        <p:txBody>
          <a:bodyPr/>
          <a:lstStyle/>
          <a:p>
            <a:r>
              <a:rPr lang="en-US" dirty="0"/>
              <a:t>Fig. 3A</a:t>
            </a:r>
          </a:p>
        </p:txBody>
      </p:sp>
    </p:spTree>
    <p:extLst>
      <p:ext uri="{BB962C8B-B14F-4D97-AF65-F5344CB8AC3E}">
        <p14:creationId xmlns:p14="http://schemas.microsoft.com/office/powerpoint/2010/main" val="5018129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lines on a white background&#10;&#10;AI-generated content may be incorrect.">
            <a:extLst>
              <a:ext uri="{FF2B5EF4-FFF2-40B4-BE49-F238E27FC236}">
                <a16:creationId xmlns:a16="http://schemas.microsoft.com/office/drawing/2014/main" id="{E3595209-D1A9-218A-8A46-AE50BD36E69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2562" y="538863"/>
            <a:ext cx="3179064" cy="2148840"/>
          </a:xfrm>
          <a:prstGeom prst="rect">
            <a:avLst/>
          </a:prstGeom>
        </p:spPr>
      </p:pic>
      <p:pic>
        <p:nvPicPr>
          <p:cNvPr id="13" name="Picture 12" descr="A black and white photo of a square&#10;&#10;AI-generated content may be incorrect.">
            <a:extLst>
              <a:ext uri="{FF2B5EF4-FFF2-40B4-BE49-F238E27FC236}">
                <a16:creationId xmlns:a16="http://schemas.microsoft.com/office/drawing/2014/main" id="{F60C52DE-9FEC-8997-3602-855B1EBADA4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2419" y="3243993"/>
            <a:ext cx="3181794" cy="3086531"/>
          </a:xfrm>
          <a:prstGeom prst="rect">
            <a:avLst/>
          </a:prstGeom>
        </p:spPr>
      </p:pic>
      <p:pic>
        <p:nvPicPr>
          <p:cNvPr id="5" name="Picture 4" descr="A black line on a white surface&#10;&#10;AI-generated content may be incorrect.">
            <a:extLst>
              <a:ext uri="{FF2B5EF4-FFF2-40B4-BE49-F238E27FC236}">
                <a16:creationId xmlns:a16="http://schemas.microsoft.com/office/drawing/2014/main" id="{E8B80117-D06F-8B2C-8D1A-D2539D5C1FC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82562" y="3902521"/>
            <a:ext cx="3419856" cy="2737104"/>
          </a:xfrm>
          <a:prstGeom prst="rect">
            <a:avLst/>
          </a:prstGeom>
        </p:spPr>
      </p:pic>
      <p:pic>
        <p:nvPicPr>
          <p:cNvPr id="7" name="Picture 6" descr="A close-up of a white sheet&#10;&#10;AI-generated content may be incorrect.">
            <a:extLst>
              <a:ext uri="{FF2B5EF4-FFF2-40B4-BE49-F238E27FC236}">
                <a16:creationId xmlns:a16="http://schemas.microsoft.com/office/drawing/2014/main" id="{97C61ECC-2576-F69F-D5C4-7892D891A08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21357209">
            <a:off x="4533388" y="-63952"/>
            <a:ext cx="3419856" cy="2737104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EF93213F-C3AC-B955-E46F-6394452CCF8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207734" y="648765"/>
            <a:ext cx="744117" cy="171442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458CA436-3BC8-440C-3E04-D4FCE034B19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42974" y="3756118"/>
            <a:ext cx="744117" cy="1714421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AF1D9436-8AED-3876-B4EA-8ED2C227B8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582562" y="4427363"/>
            <a:ext cx="738257" cy="1700920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E391B7E-59F5-325D-5DF8-3B5A63554CA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92418" y="862229"/>
            <a:ext cx="744117" cy="1714421"/>
          </a:xfrm>
          <a:prstGeom prst="rect">
            <a:avLst/>
          </a:prstGeom>
        </p:spPr>
      </p:pic>
      <p:pic>
        <p:nvPicPr>
          <p:cNvPr id="4" name="Picture 3" descr="A close-up of a test results&#10;&#10;Description automatically generated">
            <a:extLst>
              <a:ext uri="{FF2B5EF4-FFF2-40B4-BE49-F238E27FC236}">
                <a16:creationId xmlns:a16="http://schemas.microsoft.com/office/drawing/2014/main" id="{19B6BFB1-7D5F-0391-5DEE-75DF33A27130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t="24460" r="50620" b="52611"/>
          <a:stretch>
            <a:fillRect/>
          </a:stretch>
        </p:blipFill>
        <p:spPr>
          <a:xfrm>
            <a:off x="757716" y="2966408"/>
            <a:ext cx="2426208" cy="157941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413E688-8FF3-0CB2-ADAA-FE3E092B5A60}"/>
              </a:ext>
            </a:extLst>
          </p:cNvPr>
          <p:cNvSpPr txBox="1"/>
          <p:nvPr/>
        </p:nvSpPr>
        <p:spPr>
          <a:xfrm>
            <a:off x="5450618" y="153658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TRAF3IP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1ADD44D-D431-F9F5-75C3-93C1B5BCD5BB}"/>
              </a:ext>
            </a:extLst>
          </p:cNvPr>
          <p:cNvSpPr txBox="1"/>
          <p:nvPr/>
        </p:nvSpPr>
        <p:spPr>
          <a:xfrm>
            <a:off x="9421963" y="292157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NAMP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3561AC8-A314-5603-1302-EBFD19B7ADC8}"/>
              </a:ext>
            </a:extLst>
          </p:cNvPr>
          <p:cNvSpPr txBox="1"/>
          <p:nvPr/>
        </p:nvSpPr>
        <p:spPr>
          <a:xfrm>
            <a:off x="5372789" y="2890762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SIRT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1AE574F-D01C-1B75-A1A7-B0167AFB393C}"/>
              </a:ext>
            </a:extLst>
          </p:cNvPr>
          <p:cNvSpPr txBox="1"/>
          <p:nvPr/>
        </p:nvSpPr>
        <p:spPr>
          <a:xfrm>
            <a:off x="9960508" y="4031798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200" dirty="0"/>
              <a:t>β</a:t>
            </a:r>
            <a:r>
              <a:rPr lang="en-US" sz="1200" dirty="0"/>
              <a:t>-Actin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F1EB225-80F2-8FAC-B7E7-39BE8C550886}"/>
              </a:ext>
            </a:extLst>
          </p:cNvPr>
          <p:cNvSpPr/>
          <p:nvPr/>
        </p:nvSpPr>
        <p:spPr>
          <a:xfrm>
            <a:off x="5372789" y="1368046"/>
            <a:ext cx="1879771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A85F8A5-F7CE-3DB9-DCDD-9E3A303BB872}"/>
              </a:ext>
            </a:extLst>
          </p:cNvPr>
          <p:cNvSpPr/>
          <p:nvPr/>
        </p:nvSpPr>
        <p:spPr>
          <a:xfrm>
            <a:off x="9759195" y="1604359"/>
            <a:ext cx="1879771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C2B94B81-4394-2E4E-17AB-E99EB8969886}"/>
              </a:ext>
            </a:extLst>
          </p:cNvPr>
          <p:cNvSpPr/>
          <p:nvPr/>
        </p:nvSpPr>
        <p:spPr>
          <a:xfrm>
            <a:off x="5187091" y="3953860"/>
            <a:ext cx="1879771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DF9F9432-FAB2-3431-7E5F-19D752ECA376}"/>
              </a:ext>
            </a:extLst>
          </p:cNvPr>
          <p:cNvSpPr/>
          <p:nvPr/>
        </p:nvSpPr>
        <p:spPr>
          <a:xfrm>
            <a:off x="9333738" y="5164386"/>
            <a:ext cx="1879771" cy="35922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Title 19">
            <a:extLst>
              <a:ext uri="{FF2B5EF4-FFF2-40B4-BE49-F238E27FC236}">
                <a16:creationId xmlns:a16="http://schemas.microsoft.com/office/drawing/2014/main" id="{92F10BB3-6A0C-C456-77D1-39399C9A277E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3202594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Fig. 3C</a:t>
            </a:r>
          </a:p>
        </p:txBody>
      </p:sp>
    </p:spTree>
    <p:extLst>
      <p:ext uri="{BB962C8B-B14F-4D97-AF65-F5344CB8AC3E}">
        <p14:creationId xmlns:p14="http://schemas.microsoft.com/office/powerpoint/2010/main" val="1733976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A297468C-D528-771B-7FBB-21C0C166D46F}"/>
              </a:ext>
            </a:extLst>
          </p:cNvPr>
          <p:cNvGrpSpPr/>
          <p:nvPr/>
        </p:nvGrpSpPr>
        <p:grpSpPr>
          <a:xfrm>
            <a:off x="2464837" y="374948"/>
            <a:ext cx="3619881" cy="2737104"/>
            <a:chOff x="0" y="-178836"/>
            <a:chExt cx="3619881" cy="2737104"/>
          </a:xfrm>
        </p:grpSpPr>
        <p:pic>
          <p:nvPicPr>
            <p:cNvPr id="7" name="Picture 6" descr="A close-up of a black and white photo&#10;&#10;AI-generated content may be incorrect.">
              <a:extLst>
                <a:ext uri="{FF2B5EF4-FFF2-40B4-BE49-F238E27FC236}">
                  <a16:creationId xmlns:a16="http://schemas.microsoft.com/office/drawing/2014/main" id="{DC4817C9-7989-7164-57DC-CE72A76FC45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0025" y="-178836"/>
              <a:ext cx="3419856" cy="2737104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BCC5C2B-2F68-5516-20DF-4335C6473F8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399392"/>
              <a:ext cx="738257" cy="1700920"/>
            </a:xfrm>
            <a:prstGeom prst="rect">
              <a:avLst/>
            </a:prstGeom>
          </p:spPr>
        </p:pic>
      </p:grp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5D4F835-A1F6-BB2A-E0FF-FB681EC6C143}"/>
              </a:ext>
            </a:extLst>
          </p:cNvPr>
          <p:cNvGrpSpPr/>
          <p:nvPr/>
        </p:nvGrpSpPr>
        <p:grpSpPr>
          <a:xfrm>
            <a:off x="6195790" y="458450"/>
            <a:ext cx="2834953" cy="2737104"/>
            <a:chOff x="2801451" y="2299222"/>
            <a:chExt cx="2834953" cy="2737104"/>
          </a:xfrm>
        </p:grpSpPr>
        <p:pic>
          <p:nvPicPr>
            <p:cNvPr id="9" name="Picture 8" descr="A black and white photo of a rectangular object&#10;&#10;AI-generated content may be incorrect.">
              <a:extLst>
                <a:ext uri="{FF2B5EF4-FFF2-40B4-BE49-F238E27FC236}">
                  <a16:creationId xmlns:a16="http://schemas.microsoft.com/office/drawing/2014/main" id="{976C9B13-031E-A4E4-19B2-AF9398AA022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35186"/>
            <a:stretch>
              <a:fillRect/>
            </a:stretch>
          </p:blipFill>
          <p:spPr>
            <a:xfrm>
              <a:off x="3419855" y="2299222"/>
              <a:ext cx="2216549" cy="2737104"/>
            </a:xfrm>
            <a:prstGeom prst="rect">
              <a:avLst/>
            </a:prstGeom>
          </p:spPr>
        </p:pic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88200F51-80BC-C2C2-279F-3EB1E80412F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801451" y="2817313"/>
              <a:ext cx="738257" cy="1700920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67131E2-24D3-D95C-6EE3-35D142CA4C63}"/>
              </a:ext>
            </a:extLst>
          </p:cNvPr>
          <p:cNvGrpSpPr/>
          <p:nvPr/>
        </p:nvGrpSpPr>
        <p:grpSpPr>
          <a:xfrm>
            <a:off x="4529535" y="4496509"/>
            <a:ext cx="2089628" cy="1986543"/>
            <a:chOff x="5171788" y="2897450"/>
            <a:chExt cx="2089628" cy="1986543"/>
          </a:xfrm>
        </p:grpSpPr>
        <p:pic>
          <p:nvPicPr>
            <p:cNvPr id="15" name="Picture 14" descr="A blurry image of a window&#10;&#10;AI-generated content may be incorrect.">
              <a:extLst>
                <a:ext uri="{FF2B5EF4-FFF2-40B4-BE49-F238E27FC236}">
                  <a16:creationId xmlns:a16="http://schemas.microsoft.com/office/drawing/2014/main" id="{5D22E1BC-AE29-4BAD-FB5F-83095B33702B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56256" y="3171799"/>
              <a:ext cx="1505160" cy="1476581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9D2ED56-59C3-91B3-3C19-778C393913E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171788" y="2897450"/>
              <a:ext cx="862227" cy="1986543"/>
            </a:xfrm>
            <a:prstGeom prst="rect">
              <a:avLst/>
            </a:prstGeom>
          </p:spPr>
        </p:pic>
      </p:grpSp>
      <p:pic>
        <p:nvPicPr>
          <p:cNvPr id="6" name="Picture 5">
            <a:extLst>
              <a:ext uri="{FF2B5EF4-FFF2-40B4-BE49-F238E27FC236}">
                <a16:creationId xmlns:a16="http://schemas.microsoft.com/office/drawing/2014/main" id="{2B174266-3672-4CDA-E76A-00389FF604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17262" y="4560069"/>
            <a:ext cx="862227" cy="198654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44E030D-F14E-CA3C-957B-E365408374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21578" y="4542182"/>
            <a:ext cx="759328" cy="174946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378941ED-C8FA-5CA1-7FFB-1A7A6FCA8A2B}"/>
              </a:ext>
            </a:extLst>
          </p:cNvPr>
          <p:cNvSpPr txBox="1"/>
          <p:nvPr/>
        </p:nvSpPr>
        <p:spPr>
          <a:xfrm>
            <a:off x="3404251" y="209305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LKB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BFE8F7E-5D37-310F-68AF-7DDFD47BDDC7}"/>
              </a:ext>
            </a:extLst>
          </p:cNvPr>
          <p:cNvSpPr txBox="1"/>
          <p:nvPr/>
        </p:nvSpPr>
        <p:spPr>
          <a:xfrm>
            <a:off x="7115737" y="203060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-LKB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CC5F8C1-F2B7-DC49-F5D4-CC96732F88DA}"/>
              </a:ext>
            </a:extLst>
          </p:cNvPr>
          <p:cNvSpPr txBox="1"/>
          <p:nvPr/>
        </p:nvSpPr>
        <p:spPr>
          <a:xfrm>
            <a:off x="1568970" y="3700103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AMPK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3E0AE6A-4CA9-6749-0347-1C17502EDD11}"/>
              </a:ext>
            </a:extLst>
          </p:cNvPr>
          <p:cNvSpPr txBox="1"/>
          <p:nvPr/>
        </p:nvSpPr>
        <p:spPr>
          <a:xfrm>
            <a:off x="4996056" y="4122396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-AMPK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E1F5809-6CBD-061A-D4D9-A846F662AA8B}"/>
              </a:ext>
            </a:extLst>
          </p:cNvPr>
          <p:cNvSpPr txBox="1"/>
          <p:nvPr/>
        </p:nvSpPr>
        <p:spPr>
          <a:xfrm>
            <a:off x="9389917" y="3716376"/>
            <a:ext cx="6735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200" dirty="0"/>
              <a:t>Β</a:t>
            </a:r>
            <a:r>
              <a:rPr lang="en-US" sz="1200" dirty="0"/>
              <a:t>-Actin</a:t>
            </a:r>
          </a:p>
        </p:txBody>
      </p:sp>
      <p:pic>
        <p:nvPicPr>
          <p:cNvPr id="22" name="Picture 21" descr="A close-up of a graph&#10;&#10;Description automatically generated">
            <a:extLst>
              <a:ext uri="{FF2B5EF4-FFF2-40B4-BE49-F238E27FC236}">
                <a16:creationId xmlns:a16="http://schemas.microsoft.com/office/drawing/2014/main" id="{FC0CCC70-2E48-ED74-D895-39FBD1F22591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l="9676" t="5870" r="67051" b="55212"/>
          <a:stretch>
            <a:fillRect/>
          </a:stretch>
        </p:blipFill>
        <p:spPr>
          <a:xfrm>
            <a:off x="99269" y="976541"/>
            <a:ext cx="1552250" cy="1952311"/>
          </a:xfrm>
          <a:prstGeom prst="rect">
            <a:avLst/>
          </a:prstGeom>
        </p:spPr>
      </p:pic>
      <p:sp>
        <p:nvSpPr>
          <p:cNvPr id="23" name="Rectangle 22">
            <a:extLst>
              <a:ext uri="{FF2B5EF4-FFF2-40B4-BE49-F238E27FC236}">
                <a16:creationId xmlns:a16="http://schemas.microsoft.com/office/drawing/2014/main" id="{C5227BA0-B416-B4C6-3694-D60E7E1779CA}"/>
              </a:ext>
            </a:extLst>
          </p:cNvPr>
          <p:cNvSpPr/>
          <p:nvPr/>
        </p:nvSpPr>
        <p:spPr>
          <a:xfrm>
            <a:off x="4240819" y="1446695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F776F8A5-F29A-1991-D55A-54D3612627D0}"/>
              </a:ext>
            </a:extLst>
          </p:cNvPr>
          <p:cNvSpPr/>
          <p:nvPr/>
        </p:nvSpPr>
        <p:spPr>
          <a:xfrm>
            <a:off x="6934048" y="1585194"/>
            <a:ext cx="719548" cy="37423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0D9B9ECD-C4A9-AD86-0362-54DADF4DA686}"/>
              </a:ext>
            </a:extLst>
          </p:cNvPr>
          <p:cNvSpPr/>
          <p:nvPr/>
        </p:nvSpPr>
        <p:spPr>
          <a:xfrm>
            <a:off x="5349071" y="5115545"/>
            <a:ext cx="1170689" cy="39360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itle 19">
            <a:extLst>
              <a:ext uri="{FF2B5EF4-FFF2-40B4-BE49-F238E27FC236}">
                <a16:creationId xmlns:a16="http://schemas.microsoft.com/office/drawing/2014/main" id="{C6A05DCE-3DBE-FCA3-96C8-713E5687C705}"/>
              </a:ext>
            </a:extLst>
          </p:cNvPr>
          <p:cNvSpPr txBox="1">
            <a:spLocks/>
          </p:cNvSpPr>
          <p:nvPr/>
        </p:nvSpPr>
        <p:spPr>
          <a:xfrm>
            <a:off x="838200" y="365125"/>
            <a:ext cx="3202594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Fig. 4A</a:t>
            </a:r>
          </a:p>
        </p:txBody>
      </p:sp>
      <p:pic>
        <p:nvPicPr>
          <p:cNvPr id="30" name="Picture 29" descr="A close-up of a white background&#10;&#10;AI-generated content may be incorrect.">
            <a:extLst>
              <a:ext uri="{FF2B5EF4-FFF2-40B4-BE49-F238E27FC236}">
                <a16:creationId xmlns:a16="http://schemas.microsoft.com/office/drawing/2014/main" id="{B660CAAC-73EE-2D84-D4D1-2410A34589C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829" y="3929149"/>
            <a:ext cx="3419856" cy="2734056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E2216EB3-4637-4BFE-0934-459F9A4EF71C}"/>
              </a:ext>
            </a:extLst>
          </p:cNvPr>
          <p:cNvSpPr/>
          <p:nvPr/>
        </p:nvSpPr>
        <p:spPr>
          <a:xfrm>
            <a:off x="2218001" y="5176969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3" name="Picture 32" descr="A close-up of a scan&#10;&#10;AI-generated content may be incorrect.">
            <a:extLst>
              <a:ext uri="{FF2B5EF4-FFF2-40B4-BE49-F238E27FC236}">
                <a16:creationId xmlns:a16="http://schemas.microsoft.com/office/drawing/2014/main" id="{F8BEC3AA-E38C-BE32-B6EC-0FD38AAB1126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49433" y="3993375"/>
            <a:ext cx="3419856" cy="2737104"/>
          </a:xfrm>
          <a:prstGeom prst="rect">
            <a:avLst/>
          </a:prstGeom>
        </p:spPr>
      </p:pic>
      <p:sp>
        <p:nvSpPr>
          <p:cNvPr id="26" name="Rectangle 25">
            <a:extLst>
              <a:ext uri="{FF2B5EF4-FFF2-40B4-BE49-F238E27FC236}">
                <a16:creationId xmlns:a16="http://schemas.microsoft.com/office/drawing/2014/main" id="{BA092D35-2AB5-B78E-E7F6-C55B58029CFD}"/>
              </a:ext>
            </a:extLst>
          </p:cNvPr>
          <p:cNvSpPr/>
          <p:nvPr/>
        </p:nvSpPr>
        <p:spPr>
          <a:xfrm>
            <a:off x="9349859" y="5296177"/>
            <a:ext cx="753698" cy="43945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22174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black and white image of a line&#10;&#10;AI-generated content may be incorrect.">
            <a:extLst>
              <a:ext uri="{FF2B5EF4-FFF2-40B4-BE49-F238E27FC236}">
                <a16:creationId xmlns:a16="http://schemas.microsoft.com/office/drawing/2014/main" id="{49D11564-E576-0712-4158-4C1A0626F6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20407" y="2464769"/>
            <a:ext cx="2573081" cy="2371946"/>
          </a:xfrm>
          <a:prstGeom prst="rect">
            <a:avLst/>
          </a:prstGeom>
        </p:spPr>
      </p:pic>
      <p:grpSp>
        <p:nvGrpSpPr>
          <p:cNvPr id="10" name="Group 9">
            <a:extLst>
              <a:ext uri="{FF2B5EF4-FFF2-40B4-BE49-F238E27FC236}">
                <a16:creationId xmlns:a16="http://schemas.microsoft.com/office/drawing/2014/main" id="{3A638D54-BBAE-DCDB-4DBA-084A72D50125}"/>
              </a:ext>
            </a:extLst>
          </p:cNvPr>
          <p:cNvGrpSpPr/>
          <p:nvPr/>
        </p:nvGrpSpPr>
        <p:grpSpPr>
          <a:xfrm>
            <a:off x="2679422" y="417658"/>
            <a:ext cx="2313495" cy="3681169"/>
            <a:chOff x="-1359141" y="831569"/>
            <a:chExt cx="2815779" cy="4480390"/>
          </a:xfrm>
        </p:grpSpPr>
        <p:pic>
          <p:nvPicPr>
            <p:cNvPr id="9" name="Picture 8" descr="A close-up of a black and white image&#10;&#10;AI-generated content may be incorrect.">
              <a:extLst>
                <a:ext uri="{FF2B5EF4-FFF2-40B4-BE49-F238E27FC236}">
                  <a16:creationId xmlns:a16="http://schemas.microsoft.com/office/drawing/2014/main" id="{DA20A8FC-FC49-B706-0AF5-0766B1235B7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89302">
              <a:off x="-141114" y="831569"/>
              <a:ext cx="1597752" cy="4480390"/>
            </a:xfrm>
            <a:prstGeom prst="rect">
              <a:avLst/>
            </a:prstGeom>
          </p:spPr>
        </p:pic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id="{2569073C-B145-3EC9-B226-EE897AA3023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1359141" y="1233508"/>
              <a:ext cx="1193917" cy="2750746"/>
            </a:xfrm>
            <a:prstGeom prst="rect">
              <a:avLst/>
            </a:prstGeom>
          </p:spPr>
        </p:pic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5425CB94-0113-35E5-3325-167248A976A0}"/>
              </a:ext>
            </a:extLst>
          </p:cNvPr>
          <p:cNvGrpSpPr/>
          <p:nvPr/>
        </p:nvGrpSpPr>
        <p:grpSpPr>
          <a:xfrm>
            <a:off x="5062555" y="521650"/>
            <a:ext cx="1765244" cy="2590899"/>
            <a:chOff x="1632618" y="277610"/>
            <a:chExt cx="2784219" cy="4086478"/>
          </a:xfrm>
        </p:grpSpPr>
        <p:pic>
          <p:nvPicPr>
            <p:cNvPr id="3" name="Picture 2" descr="A blurry image of a person's face&#10;&#10;AI-generated content may be incorrect.">
              <a:extLst>
                <a:ext uri="{FF2B5EF4-FFF2-40B4-BE49-F238E27FC236}">
                  <a16:creationId xmlns:a16="http://schemas.microsoft.com/office/drawing/2014/main" id="{86EB0938-01C3-7971-9F17-EC584F96191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08067" y="277610"/>
              <a:ext cx="1308770" cy="4071996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A4EE1894-ADCF-3137-8195-FD07C348034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32618" y="682919"/>
              <a:ext cx="1597752" cy="3681169"/>
            </a:xfrm>
            <a:prstGeom prst="rect">
              <a:avLst/>
            </a:prstGeom>
          </p:spPr>
        </p:pic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BC1C522B-193A-164D-9E99-D64227E1143C}"/>
              </a:ext>
            </a:extLst>
          </p:cNvPr>
          <p:cNvGrpSpPr/>
          <p:nvPr/>
        </p:nvGrpSpPr>
        <p:grpSpPr>
          <a:xfrm>
            <a:off x="5010132" y="3606076"/>
            <a:ext cx="2728355" cy="2826833"/>
            <a:chOff x="3277916" y="2943071"/>
            <a:chExt cx="2728355" cy="2826833"/>
          </a:xfrm>
        </p:grpSpPr>
        <p:pic>
          <p:nvPicPr>
            <p:cNvPr id="11" name="Picture 10" descr="A close-up of a dna test&#10;&#10;AI-generated content may be incorrect.">
              <a:extLst>
                <a:ext uri="{FF2B5EF4-FFF2-40B4-BE49-F238E27FC236}">
                  <a16:creationId xmlns:a16="http://schemas.microsoft.com/office/drawing/2014/main" id="{DF0FC6F3-FAC1-8D98-B37A-264F488A02F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21408430">
              <a:off x="4279350" y="2989005"/>
              <a:ext cx="1726921" cy="2780899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772CEBCF-0E13-E6AB-E749-2FC35639B56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277916" y="2943071"/>
              <a:ext cx="1073496" cy="2473301"/>
            </a:xfrm>
            <a:prstGeom prst="rect">
              <a:avLst/>
            </a:prstGeom>
          </p:spPr>
        </p:pic>
      </p:grpSp>
      <p:grpSp>
        <p:nvGrpSpPr>
          <p:cNvPr id="15" name="Group 14">
            <a:extLst>
              <a:ext uri="{FF2B5EF4-FFF2-40B4-BE49-F238E27FC236}">
                <a16:creationId xmlns:a16="http://schemas.microsoft.com/office/drawing/2014/main" id="{C0C25C24-833B-ABD7-D616-326D278BEF13}"/>
              </a:ext>
            </a:extLst>
          </p:cNvPr>
          <p:cNvGrpSpPr/>
          <p:nvPr/>
        </p:nvGrpSpPr>
        <p:grpSpPr>
          <a:xfrm>
            <a:off x="1944885" y="3525279"/>
            <a:ext cx="2806041" cy="2503237"/>
            <a:chOff x="5284989" y="3223586"/>
            <a:chExt cx="2806041" cy="2503237"/>
          </a:xfrm>
        </p:grpSpPr>
        <p:pic>
          <p:nvPicPr>
            <p:cNvPr id="16" name="Picture 15" descr="A close-up of a blue arrow&#10;&#10;AI-generated content may be incorrect.">
              <a:extLst>
                <a:ext uri="{FF2B5EF4-FFF2-40B4-BE49-F238E27FC236}">
                  <a16:creationId xmlns:a16="http://schemas.microsoft.com/office/drawing/2014/main" id="{171D5484-A1F3-BE9C-BCEB-40FFF38360A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1478" y="3639019"/>
              <a:ext cx="1719552" cy="1499832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FCFA2D58-4648-9049-36BD-58D3F8AA5F3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284989" y="3223586"/>
              <a:ext cx="1086489" cy="2503237"/>
            </a:xfrm>
            <a:prstGeom prst="rect">
              <a:avLst/>
            </a:prstGeom>
          </p:spPr>
        </p:pic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95ACF479-37FF-A3C6-B1FE-7C8CFC3CCECE}"/>
              </a:ext>
            </a:extLst>
          </p:cNvPr>
          <p:cNvSpPr txBox="1"/>
          <p:nvPr/>
        </p:nvSpPr>
        <p:spPr>
          <a:xfrm>
            <a:off x="3404251" y="209305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LKB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5BA6D27-F717-1E7E-D53F-37ABC24F1F9D}"/>
              </a:ext>
            </a:extLst>
          </p:cNvPr>
          <p:cNvSpPr txBox="1"/>
          <p:nvPr/>
        </p:nvSpPr>
        <p:spPr>
          <a:xfrm>
            <a:off x="5475841" y="209305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-LKB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1D15AE1-2E37-B8B1-DB5D-3460F6C3BCDC}"/>
              </a:ext>
            </a:extLst>
          </p:cNvPr>
          <p:cNvSpPr txBox="1"/>
          <p:nvPr/>
        </p:nvSpPr>
        <p:spPr>
          <a:xfrm>
            <a:off x="3171594" y="3195554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AMPK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B3EEA14-A551-BD0B-38BD-718034BFD133}"/>
              </a:ext>
            </a:extLst>
          </p:cNvPr>
          <p:cNvSpPr txBox="1"/>
          <p:nvPr/>
        </p:nvSpPr>
        <p:spPr>
          <a:xfrm>
            <a:off x="5957272" y="3205990"/>
            <a:ext cx="1741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/>
              <a:t>P-AMPK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53375EC-7A0A-807D-94FD-5B593430B5CC}"/>
              </a:ext>
            </a:extLst>
          </p:cNvPr>
          <p:cNvSpPr txBox="1"/>
          <p:nvPr/>
        </p:nvSpPr>
        <p:spPr>
          <a:xfrm>
            <a:off x="9974965" y="2187770"/>
            <a:ext cx="6639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l-GR" sz="1200" dirty="0"/>
              <a:t>β</a:t>
            </a:r>
            <a:r>
              <a:rPr lang="en-US" sz="1200" dirty="0"/>
              <a:t>-Actin</a:t>
            </a:r>
          </a:p>
        </p:txBody>
      </p:sp>
      <p:pic>
        <p:nvPicPr>
          <p:cNvPr id="24" name="Picture 23" descr="A close-up of a graph&#10;&#10;Description automatically generated">
            <a:extLst>
              <a:ext uri="{FF2B5EF4-FFF2-40B4-BE49-F238E27FC236}">
                <a16:creationId xmlns:a16="http://schemas.microsoft.com/office/drawing/2014/main" id="{D7421BC9-7B93-4484-AA53-1EB723E11EAC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l="31573" t="5870" r="54806" b="55212"/>
          <a:stretch>
            <a:fillRect/>
          </a:stretch>
        </p:blipFill>
        <p:spPr>
          <a:xfrm>
            <a:off x="800824" y="2777156"/>
            <a:ext cx="908469" cy="1952311"/>
          </a:xfrm>
          <a:prstGeom prst="rect">
            <a:avLst/>
          </a:prstGeom>
        </p:spPr>
      </p:pic>
      <p:sp>
        <p:nvSpPr>
          <p:cNvPr id="25" name="Title 19">
            <a:extLst>
              <a:ext uri="{FF2B5EF4-FFF2-40B4-BE49-F238E27FC236}">
                <a16:creationId xmlns:a16="http://schemas.microsoft.com/office/drawing/2014/main" id="{231D3DB4-3E38-C452-B33E-A99750A10015}"/>
              </a:ext>
            </a:extLst>
          </p:cNvPr>
          <p:cNvSpPr txBox="1">
            <a:spLocks/>
          </p:cNvSpPr>
          <p:nvPr/>
        </p:nvSpPr>
        <p:spPr>
          <a:xfrm>
            <a:off x="294928" y="369000"/>
            <a:ext cx="1899430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Fig. 4A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8F05BF0-FFBD-EABE-3230-B39D8024E727}"/>
              </a:ext>
            </a:extLst>
          </p:cNvPr>
          <p:cNvSpPr/>
          <p:nvPr/>
        </p:nvSpPr>
        <p:spPr>
          <a:xfrm>
            <a:off x="4028018" y="1600930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25575D7C-E34F-6390-E26D-046BEEEE0498}"/>
              </a:ext>
            </a:extLst>
          </p:cNvPr>
          <p:cNvSpPr/>
          <p:nvPr/>
        </p:nvSpPr>
        <p:spPr>
          <a:xfrm>
            <a:off x="3678892" y="4424418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3D64278A-D8B9-5FB2-81FD-22F3C650CE9C}"/>
              </a:ext>
            </a:extLst>
          </p:cNvPr>
          <p:cNvSpPr/>
          <p:nvPr/>
        </p:nvSpPr>
        <p:spPr>
          <a:xfrm>
            <a:off x="6053004" y="1769191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ADAA30CB-5BA1-A0DD-5A46-C20FD8B9F6FC}"/>
              </a:ext>
            </a:extLst>
          </p:cNvPr>
          <p:cNvSpPr/>
          <p:nvPr/>
        </p:nvSpPr>
        <p:spPr>
          <a:xfrm>
            <a:off x="6771062" y="4552128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CE02558F-225D-B26C-3E4B-A3E939353072}"/>
              </a:ext>
            </a:extLst>
          </p:cNvPr>
          <p:cNvSpPr/>
          <p:nvPr/>
        </p:nvSpPr>
        <p:spPr>
          <a:xfrm>
            <a:off x="10411468" y="3493059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64107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DAE5144-69F0-7443-3264-A482A2D9A2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1F08991B-E2C1-872F-4307-C34E14B8575B}"/>
              </a:ext>
            </a:extLst>
          </p:cNvPr>
          <p:cNvGrpSpPr/>
          <p:nvPr/>
        </p:nvGrpSpPr>
        <p:grpSpPr>
          <a:xfrm>
            <a:off x="3505067" y="650386"/>
            <a:ext cx="2524083" cy="2351606"/>
            <a:chOff x="4046243" y="2049978"/>
            <a:chExt cx="2524083" cy="2351606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6F9CF436-3A44-117A-3EC1-CC39CFCDC76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6646" t="22509" r="31343" b="47240"/>
            <a:stretch>
              <a:fillRect/>
            </a:stretch>
          </p:blipFill>
          <p:spPr>
            <a:xfrm>
              <a:off x="4873891" y="2326977"/>
              <a:ext cx="1651819" cy="2074607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88C6DCC5-4597-D9D2-9CBB-681D8EE7D71B}"/>
                </a:ext>
              </a:extLst>
            </p:cNvPr>
            <p:cNvSpPr txBox="1"/>
            <p:nvPr/>
          </p:nvSpPr>
          <p:spPr>
            <a:xfrm>
              <a:off x="4829272" y="2049978"/>
              <a:ext cx="17410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-Ribosomal Protein S6</a:t>
              </a:r>
            </a:p>
          </p:txBody>
        </p: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806D985-3CCF-4263-A118-C88F05476E7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046243" y="2326977"/>
              <a:ext cx="827648" cy="1906873"/>
            </a:xfrm>
            <a:prstGeom prst="rect">
              <a:avLst/>
            </a:prstGeom>
          </p:spPr>
        </p:pic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C5558D5E-45FA-D350-29B3-21F1FEF0AD9E}"/>
              </a:ext>
            </a:extLst>
          </p:cNvPr>
          <p:cNvGrpSpPr/>
          <p:nvPr/>
        </p:nvGrpSpPr>
        <p:grpSpPr>
          <a:xfrm>
            <a:off x="6029150" y="650386"/>
            <a:ext cx="2334213" cy="2421887"/>
            <a:chOff x="4564475" y="2279388"/>
            <a:chExt cx="2334213" cy="2421887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B9649400-E431-3922-5EC2-2787A53F25B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72277" t="21935" b="46954"/>
            <a:stretch>
              <a:fillRect/>
            </a:stretch>
          </p:blipFill>
          <p:spPr>
            <a:xfrm rot="21331212">
              <a:off x="5380734" y="2567675"/>
              <a:ext cx="1430532" cy="213360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9E84383-DE82-53E6-C9DF-705BF94D9203}"/>
                </a:ext>
              </a:extLst>
            </p:cNvPr>
            <p:cNvSpPr txBox="1"/>
            <p:nvPr/>
          </p:nvSpPr>
          <p:spPr>
            <a:xfrm>
              <a:off x="5293312" y="2279388"/>
              <a:ext cx="16053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Ribosomal Protein S6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9167B781-6EA5-FD19-14A0-2B7E5B604EB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564475" y="2640412"/>
              <a:ext cx="878470" cy="2023963"/>
            </a:xfrm>
            <a:prstGeom prst="rect">
              <a:avLst/>
            </a:prstGeom>
          </p:spPr>
        </p:pic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0ECABE24-F71A-9EF3-251A-DFA399037C61}"/>
              </a:ext>
            </a:extLst>
          </p:cNvPr>
          <p:cNvGrpSpPr/>
          <p:nvPr/>
        </p:nvGrpSpPr>
        <p:grpSpPr>
          <a:xfrm>
            <a:off x="3273754" y="3278991"/>
            <a:ext cx="2710780" cy="2798427"/>
            <a:chOff x="4220962" y="1908221"/>
            <a:chExt cx="2710780" cy="2798427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C5365F1E-0E23-BA20-8C66-5AC7866A138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2347" t="57778" r="65260" b="5950"/>
            <a:stretch>
              <a:fillRect/>
            </a:stretch>
          </p:blipFill>
          <p:spPr>
            <a:xfrm>
              <a:off x="5260259" y="2185220"/>
              <a:ext cx="1671483" cy="2487561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9132610-17F1-86DA-18AC-000F4A0649E2}"/>
                </a:ext>
              </a:extLst>
            </p:cNvPr>
            <p:cNvSpPr txBox="1"/>
            <p:nvPr/>
          </p:nvSpPr>
          <p:spPr>
            <a:xfrm>
              <a:off x="5314445" y="1908221"/>
              <a:ext cx="15631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/>
                <a:t>P-Protein Kinase C </a:t>
              </a:r>
              <a:r>
                <a:rPr lang="el-GR" sz="1200" dirty="0"/>
                <a:t>α</a:t>
              </a:r>
              <a:r>
                <a:rPr lang="en-US" sz="1200" dirty="0"/>
                <a:t> </a:t>
              </a:r>
            </a:p>
          </p:txBody>
        </p:sp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86C896A-11CD-D387-7184-E00617D7965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20962" y="2312145"/>
              <a:ext cx="1039297" cy="2394503"/>
            </a:xfrm>
            <a:prstGeom prst="rect">
              <a:avLst/>
            </a:prstGeom>
          </p:spPr>
        </p:pic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D64F0A19-80B9-50C8-C4D2-1CFD29C8124E}"/>
              </a:ext>
            </a:extLst>
          </p:cNvPr>
          <p:cNvGrpSpPr/>
          <p:nvPr/>
        </p:nvGrpSpPr>
        <p:grpSpPr>
          <a:xfrm>
            <a:off x="5949287" y="3337982"/>
            <a:ext cx="2549507" cy="2830190"/>
            <a:chOff x="4328053" y="1952466"/>
            <a:chExt cx="2549507" cy="2830190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737842CD-D69B-15C0-98CA-47669BAD396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36647" t="57921" r="36678" b="7097"/>
            <a:stretch>
              <a:fillRect/>
            </a:stretch>
          </p:blipFill>
          <p:spPr>
            <a:xfrm>
              <a:off x="5407742" y="2229465"/>
              <a:ext cx="1376516" cy="2399071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3EA34AE-6033-5B54-10AD-F918E8816F3F}"/>
                </a:ext>
              </a:extLst>
            </p:cNvPr>
            <p:cNvSpPr txBox="1"/>
            <p:nvPr/>
          </p:nvSpPr>
          <p:spPr>
            <a:xfrm>
              <a:off x="5314440" y="1952466"/>
              <a:ext cx="156312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P-Protein Kinase C </a:t>
              </a:r>
              <a:r>
                <a:rPr lang="el-GR" sz="1200" dirty="0"/>
                <a:t>α</a:t>
              </a:r>
              <a:r>
                <a:rPr lang="en-US" sz="1200" dirty="0"/>
                <a:t> </a:t>
              </a:r>
            </a:p>
          </p:txBody>
        </p: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D17B70E-8E11-D3C4-BE5D-B77D768E890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328053" y="2295095"/>
              <a:ext cx="1079688" cy="2487561"/>
            </a:xfrm>
            <a:prstGeom prst="rect">
              <a:avLst/>
            </a:prstGeom>
          </p:spPr>
        </p:pic>
      </p:grpSp>
      <p:grpSp>
        <p:nvGrpSpPr>
          <p:cNvPr id="18" name="Group 17">
            <a:extLst>
              <a:ext uri="{FF2B5EF4-FFF2-40B4-BE49-F238E27FC236}">
                <a16:creationId xmlns:a16="http://schemas.microsoft.com/office/drawing/2014/main" id="{2748F173-3525-85A2-EE76-FCE16D134B30}"/>
              </a:ext>
            </a:extLst>
          </p:cNvPr>
          <p:cNvGrpSpPr/>
          <p:nvPr/>
        </p:nvGrpSpPr>
        <p:grpSpPr>
          <a:xfrm>
            <a:off x="8948290" y="1964688"/>
            <a:ext cx="2601511" cy="2710484"/>
            <a:chOff x="4261406" y="1952466"/>
            <a:chExt cx="2601511" cy="2710484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AF8BF2C0-7A7E-5957-014E-4ED768F2D8C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68657" t="57921" r="1618" b="6093"/>
            <a:stretch>
              <a:fillRect/>
            </a:stretch>
          </p:blipFill>
          <p:spPr>
            <a:xfrm>
              <a:off x="5329083" y="2195052"/>
              <a:ext cx="1533834" cy="2467897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17F923F-DA25-34E0-668E-DA63D006DDDF}"/>
                </a:ext>
              </a:extLst>
            </p:cNvPr>
            <p:cNvSpPr txBox="1"/>
            <p:nvPr/>
          </p:nvSpPr>
          <p:spPr>
            <a:xfrm>
              <a:off x="5759211" y="1952466"/>
              <a:ext cx="6735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l-GR" sz="1200" dirty="0"/>
                <a:t>Β</a:t>
              </a:r>
              <a:r>
                <a:rPr lang="en-US" sz="1200" dirty="0"/>
                <a:t>-Actin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9F6B2E76-1EF6-E11F-72E5-C009F5C182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61406" y="2229466"/>
              <a:ext cx="1056217" cy="2433484"/>
            </a:xfrm>
            <a:prstGeom prst="rect">
              <a:avLst/>
            </a:prstGeom>
          </p:spPr>
        </p:pic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B861B5B2-919E-ED99-A51E-C17277ADBDA3}"/>
              </a:ext>
            </a:extLst>
          </p:cNvPr>
          <p:cNvGrpSpPr/>
          <p:nvPr/>
        </p:nvGrpSpPr>
        <p:grpSpPr>
          <a:xfrm>
            <a:off x="665220" y="2207274"/>
            <a:ext cx="1828800" cy="1896533"/>
            <a:chOff x="3335867" y="660400"/>
            <a:chExt cx="1828800" cy="1896533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93D3516A-BDC7-B7F0-FCE2-BAB3B43DFFE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rcRect l="114" t="9630" r="64444" b="62716"/>
            <a:stretch>
              <a:fillRect/>
            </a:stretch>
          </p:blipFill>
          <p:spPr>
            <a:xfrm>
              <a:off x="3335867" y="660400"/>
              <a:ext cx="1828800" cy="1896533"/>
            </a:xfrm>
            <a:prstGeom prst="rect">
              <a:avLst/>
            </a:prstGeom>
          </p:spPr>
        </p:pic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DDF6A914-F559-1C54-5390-A3C43FE80E70}"/>
                </a:ext>
              </a:extLst>
            </p:cNvPr>
            <p:cNvSpPr/>
            <p:nvPr/>
          </p:nvSpPr>
          <p:spPr>
            <a:xfrm>
              <a:off x="3505200" y="694267"/>
              <a:ext cx="321733" cy="3048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5" name="Title 19">
            <a:extLst>
              <a:ext uri="{FF2B5EF4-FFF2-40B4-BE49-F238E27FC236}">
                <a16:creationId xmlns:a16="http://schemas.microsoft.com/office/drawing/2014/main" id="{86927BFE-67FC-B42C-4B6F-098B0AB0967E}"/>
              </a:ext>
            </a:extLst>
          </p:cNvPr>
          <p:cNvSpPr txBox="1">
            <a:spLocks/>
          </p:cNvSpPr>
          <p:nvPr/>
        </p:nvSpPr>
        <p:spPr>
          <a:xfrm>
            <a:off x="294928" y="369000"/>
            <a:ext cx="1899430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/>
              <a:t>Fig. 4C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C1C51262-173C-81BD-F763-E839D458E6F5}"/>
              </a:ext>
            </a:extLst>
          </p:cNvPr>
          <p:cNvSpPr/>
          <p:nvPr/>
        </p:nvSpPr>
        <p:spPr>
          <a:xfrm>
            <a:off x="4523977" y="1964688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491C1543-DA9B-9A1E-9483-FC31B742E54D}"/>
              </a:ext>
            </a:extLst>
          </p:cNvPr>
          <p:cNvSpPr/>
          <p:nvPr/>
        </p:nvSpPr>
        <p:spPr>
          <a:xfrm>
            <a:off x="7133094" y="2207274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EC74CFC-0096-6F79-9C61-DCBC56D84C55}"/>
              </a:ext>
            </a:extLst>
          </p:cNvPr>
          <p:cNvSpPr/>
          <p:nvPr/>
        </p:nvSpPr>
        <p:spPr>
          <a:xfrm>
            <a:off x="5006868" y="4528986"/>
            <a:ext cx="63464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A90C3223-C1DD-5D43-567D-CE8519F06F76}"/>
              </a:ext>
            </a:extLst>
          </p:cNvPr>
          <p:cNvSpPr/>
          <p:nvPr/>
        </p:nvSpPr>
        <p:spPr>
          <a:xfrm>
            <a:off x="7582118" y="4658682"/>
            <a:ext cx="688018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0213A774-559E-D71E-6EAD-C7DE53142EAE}"/>
              </a:ext>
            </a:extLst>
          </p:cNvPr>
          <p:cNvSpPr/>
          <p:nvPr/>
        </p:nvSpPr>
        <p:spPr>
          <a:xfrm>
            <a:off x="10015968" y="3337982"/>
            <a:ext cx="855232" cy="34493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103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657</TotalTime>
  <Words>69</Words>
  <Application>Microsoft Macintosh PowerPoint</Application>
  <PresentationFormat>Widescreen</PresentationFormat>
  <Paragraphs>36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ptos</vt:lpstr>
      <vt:lpstr>Aptos Display</vt:lpstr>
      <vt:lpstr>Arial</vt:lpstr>
      <vt:lpstr>Office Theme</vt:lpstr>
      <vt:lpstr>Fig. 3A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illingham, Kurtis A</dc:creator>
  <cp:lastModifiedBy>Izadpanah, Reza</cp:lastModifiedBy>
  <cp:revision>8</cp:revision>
  <dcterms:created xsi:type="dcterms:W3CDTF">2025-10-09T06:14:40Z</dcterms:created>
  <dcterms:modified xsi:type="dcterms:W3CDTF">2025-10-27T17:24:03Z</dcterms:modified>
</cp:coreProperties>
</file>